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13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E$10:$G$10</c:f>
                <c:numCache>
                  <c:formatCode>General</c:formatCode>
                  <c:ptCount val="3"/>
                  <c:pt idx="0">
                    <c:v>0.26584000000000002</c:v>
                  </c:pt>
                  <c:pt idx="1">
                    <c:v>4.6820000000000001E-2</c:v>
                  </c:pt>
                  <c:pt idx="2">
                    <c:v>7.56349999999999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8:$G$8</c:f>
              <c:strCache>
                <c:ptCount val="3"/>
                <c:pt idx="0">
                  <c:v>RACMx1</c:v>
                </c:pt>
                <c:pt idx="1">
                  <c:v>B1Abx1</c:v>
                </c:pt>
                <c:pt idx="2">
                  <c:v>B1Abx10</c:v>
                </c:pt>
              </c:strCache>
            </c:strRef>
          </c:cat>
          <c:val>
            <c:numRef>
              <c:f>Sheet1!$E$9:$G$9</c:f>
              <c:numCache>
                <c:formatCode>General</c:formatCode>
                <c:ptCount val="3"/>
                <c:pt idx="0">
                  <c:v>1</c:v>
                </c:pt>
                <c:pt idx="1">
                  <c:v>0.19324</c:v>
                </c:pt>
                <c:pt idx="2">
                  <c:v>0.132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627152"/>
        <c:axId val="-1452617904"/>
      </c:barChart>
      <c:catAx>
        <c:axId val="-1452627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617904"/>
        <c:crosses val="autoZero"/>
        <c:auto val="1"/>
        <c:lblAlgn val="ctr"/>
        <c:lblOffset val="100"/>
        <c:noMultiLvlLbl val="0"/>
      </c:catAx>
      <c:valAx>
        <c:axId val="-1452617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62715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813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251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489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454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5598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1351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829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931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07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2798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127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C4D65-FA98-4A8B-A84D-4187F1021A0C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ADB11-072B-4474-8644-C0FFB17B37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2678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/>
          </p:nvPr>
        </p:nvGraphicFramePr>
        <p:xfrm>
          <a:off x="2257418" y="1124779"/>
          <a:ext cx="2135688" cy="2195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3461283" y="2305521"/>
            <a:ext cx="439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n.s</a:t>
            </a:r>
            <a:r>
              <a:rPr kumimoji="1" lang="en-US" altLang="ja-JP" sz="1400" dirty="0" smtClean="0"/>
              <a:t>.</a:t>
            </a:r>
            <a:endParaRPr kumimoji="1" lang="ja-JP" altLang="en-US" sz="14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55381" y="862394"/>
            <a:ext cx="817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i="1" dirty="0" smtClean="0"/>
              <a:t>TNFα</a:t>
            </a:r>
            <a:endParaRPr kumimoji="1" lang="ja-JP" altLang="en-US" sz="1600" b="1" i="1" dirty="0"/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1269835" y="1965438"/>
            <a:ext cx="17691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/>
              <a:t>mRNA</a:t>
            </a:r>
            <a:r>
              <a:rPr lang="ja-JP" altLang="en-US" sz="1200" dirty="0" smtClean="0"/>
              <a:t> </a:t>
            </a:r>
            <a:r>
              <a:rPr lang="en-US" altLang="ja-JP" sz="1200" dirty="0" smtClean="0"/>
              <a:t>levels of BV-2 cells</a:t>
            </a:r>
          </a:p>
          <a:p>
            <a:pPr algn="ctr"/>
            <a:r>
              <a:rPr kumimoji="1" lang="en-US" altLang="ja-JP" sz="1200" dirty="0" smtClean="0"/>
              <a:t>(fold/GAPDH)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862808" y="3251658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β1Ab</a:t>
            </a:r>
            <a:endParaRPr kumimoji="1" lang="ja-JP" altLang="en-US" sz="1400" dirty="0"/>
          </a:p>
        </p:txBody>
      </p:sp>
      <p:sp>
        <p:nvSpPr>
          <p:cNvPr id="11" name="正方形/長方形 10"/>
          <p:cNvSpPr/>
          <p:nvPr/>
        </p:nvSpPr>
        <p:spPr>
          <a:xfrm>
            <a:off x="2544052" y="3103896"/>
            <a:ext cx="1801269" cy="1143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698251" y="3238095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735617" y="3241456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x10</a:t>
            </a:r>
            <a:endParaRPr kumimoji="1" lang="ja-JP" altLang="en-US" sz="14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816657" y="2988239"/>
            <a:ext cx="635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RACM</a:t>
            </a:r>
            <a:endParaRPr kumimoji="1" lang="ja-JP" altLang="en-US" sz="1400" dirty="0"/>
          </a:p>
        </p:txBody>
      </p:sp>
      <p:cxnSp>
        <p:nvCxnSpPr>
          <p:cNvPr id="19" name="直線コネクタ 18"/>
          <p:cNvCxnSpPr/>
          <p:nvPr/>
        </p:nvCxnSpPr>
        <p:spPr>
          <a:xfrm>
            <a:off x="2588963" y="3260868"/>
            <a:ext cx="166022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2596106" y="3522806"/>
            <a:ext cx="166022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3143474" y="3020489"/>
            <a:ext cx="0" cy="75949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3697265" y="3020521"/>
            <a:ext cx="0" cy="75945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>
            <a:off x="4252045" y="3018108"/>
            <a:ext cx="0" cy="769822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2589440" y="3020489"/>
            <a:ext cx="0" cy="76744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-162" y="-2539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Figure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8.</a:t>
            </a:r>
            <a:endParaRPr kumimoji="1" lang="ja-JP" altLang="en-US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704649" y="3543771"/>
            <a:ext cx="963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Control Ab</a:t>
            </a:r>
            <a:endParaRPr kumimoji="1" lang="ja-JP" altLang="en-US" sz="1400" dirty="0"/>
          </a:p>
        </p:txBody>
      </p:sp>
      <p:cxnSp>
        <p:nvCxnSpPr>
          <p:cNvPr id="27" name="直線コネクタ 26"/>
          <p:cNvCxnSpPr/>
          <p:nvPr/>
        </p:nvCxnSpPr>
        <p:spPr>
          <a:xfrm>
            <a:off x="2588963" y="3779980"/>
            <a:ext cx="166022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/>
          <p:cNvSpPr txBox="1"/>
          <p:nvPr/>
        </p:nvSpPr>
        <p:spPr>
          <a:xfrm>
            <a:off x="3255463" y="3487224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811081" y="3495442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681773" y="348722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675739" y="296855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235503" y="296855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792171" y="296855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237391" y="32257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714781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</Words>
  <Application>Microsoft Office PowerPoint</Application>
  <PresentationFormat>A4 210 x 297 mm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Kyushu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崎 真吾</dc:creator>
  <cp:lastModifiedBy>吉崎 真吾</cp:lastModifiedBy>
  <cp:revision>1</cp:revision>
  <dcterms:created xsi:type="dcterms:W3CDTF">2020-11-06T12:17:49Z</dcterms:created>
  <dcterms:modified xsi:type="dcterms:W3CDTF">2020-11-06T12:18:14Z</dcterms:modified>
</cp:coreProperties>
</file>